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Masters/slideMaster1.xml" ContentType="application/vnd.openxmlformats-officedocument.presentationml.slideMaster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theme/theme1.xml" ContentType="application/vnd.openxmlformats-officedocument.theme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style6.xml" ContentType="application/vnd.ms-office.chartstyle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olors5.xml" ContentType="application/vnd.ms-office.chartcolorstyle+xml"/>
  <Override PartName="/ppt/charts/style5.xml" ContentType="application/vnd.ms-office.chartstyle+xml"/>
  <Override PartName="/ppt/charts/chart5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olors6.xml" ContentType="application/vnd.ms-office.chartcolorstyl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72" r:id="rId1"/>
  </p:sldMasterIdLst>
  <p:notesMasterIdLst>
    <p:notesMasterId r:id="rId4"/>
  </p:notesMasterIdLst>
  <p:sldIdLst>
    <p:sldId id="262" r:id="rId2"/>
    <p:sldId id="264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ünkel, Anna" initials="DA" lastIdx="1" clrIdx="0">
    <p:extLst>
      <p:ext uri="{19B8F6BF-5375-455C-9EA6-DF929625EA0E}">
        <p15:presenceInfo xmlns:p15="http://schemas.microsoft.com/office/powerpoint/2012/main" userId="S::anna.duenkel@izi.fraunhofer.de::389e6d3e-fe5d-4347-91b8-7bb40b548a3f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6" autoAdjust="0"/>
    <p:restoredTop sz="94660"/>
  </p:normalViewPr>
  <p:slideViewPr>
    <p:cSldViewPr snapToGrid="0" showGuides="1">
      <p:cViewPr varScale="1">
        <p:scale>
          <a:sx n="76" d="100"/>
          <a:sy n="76" d="100"/>
        </p:scale>
        <p:origin x="2400" y="10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12" Type="http://schemas.openxmlformats.org/officeDocument/2006/relationships/customXml" Target="../customXml/item3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openxmlformats.org/officeDocument/2006/relationships/customXml" Target="../customXml/item2.xml"/><Relationship Id="rId5" Type="http://schemas.openxmlformats.org/officeDocument/2006/relationships/commentAuthors" Target="commentAuthors.xml"/><Relationship Id="rId10" Type="http://schemas.openxmlformats.org/officeDocument/2006/relationships/customXml" Target="../customXml/item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ranos.izi.fraunhofer.de\oe_700$\03.Projekte%20GMPDU\Cellbox\Cellbox_Berichte\Paper\20250107_CB_Paper_final\supplement_data\Supplemental_data_06_Cytotoxicity\Archiv\20240624_Calcein_Donor%201-8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ranos.izi.fraunhofer.de\oe_700$\03.Projekte%20GMPDU\Cellbox\Cellbox_Berichte\Paper\20250107_CB_Paper_final\supplement_data\Supplemental_data_06_Cytotoxicity\Archiv\20240624_Calcein_Donor%201-8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ranos.izi.fraunhofer.de\oe_700$\03.Projekte%20GMPDU\Cellbox\Cellbox_Berichte\Paper\20250107_CB_Paper_final\supplement_data\Supplemental_data_06_Cytotoxicity\Archiv\20240624_Calcein_Donor%201-8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ranos.izi.fraunhofer.de\oe_700$\03.Projekte%20GMPDU\Cellbox\Cellbox_Berichte\Paper\20250107_CB_Paper_final\supplement_data\Supplemental_data_06_Cytotoxicity\Archiv\20240624_Calcein_Donor%201-8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ranos.izi.fraunhofer.de\oe_700$\03.Projekte%20GMPDU\Cellbox\Cellbox_Berichte\Paper\20250107_CB_Paper_final\supplement_data\Supplemental_data_06_Cytotoxicity\Archiv\20240624_Calcein_Donor%201-8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uranos.izi.fraunhofer.de\oe_700$\03.Projekte%20GMPDU\Cellbox\Cellbox_Berichte\Paper\20250107_CB_Paper_final\supplement_data\Supplemental_data_06_Cytotoxicity\Archiv\20240624_Calcein_Donor%201-8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uranos.izi.fraunhofer.de\oe_700$\03.Projekte%20GMPDU\Cellbox\Cellbox_Berichte\Paper\20250107_CB_Paper_final\supplement_data\Supplemental_data_06_Cytotoxicity\Archiv\20240624_Calcein_Donor%201-8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\\uranos.izi.fraunhofer.de\oe_700$\03.Projekte%20GMPDU\Cellbox\Cellbox_Berichte\Paper\20250107_CB_Paper_final\supplement_data\Supplemental_data_06_Cytotoxicity\Archiv\20240624_Calcein_Donor%201-8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\\uranos.izi.fraunhofer.de\oe_700$\03.Projekte%20GMPDU\Cellbox\Cellbox_Berichte\Paper\20250107_CB_Paper_final\supplement_data\Supplemental_data_06_Cytotoxicity\Archiv\20240624_Calcein_Donor%201-8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v>Donor 1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00_NKC expansion_phase'!$C$15:$F$15</c:f>
              <c:numCache>
                <c:formatCode>General</c:formatCode>
                <c:ptCount val="4"/>
                <c:pt idx="0">
                  <c:v>0.1</c:v>
                </c:pt>
                <c:pt idx="1">
                  <c:v>0.5</c:v>
                </c:pt>
                <c:pt idx="2">
                  <c:v>1</c:v>
                </c:pt>
                <c:pt idx="3">
                  <c:v>5</c:v>
                </c:pt>
              </c:numCache>
            </c:numRef>
          </c:xVal>
          <c:yVal>
            <c:numRef>
              <c:f>'00_NKC expansion_phase'!$C$16:$F$16</c:f>
              <c:numCache>
                <c:formatCode>0.00</c:formatCode>
                <c:ptCount val="4"/>
                <c:pt idx="0">
                  <c:v>18.760311939891036</c:v>
                </c:pt>
                <c:pt idx="1">
                  <c:v>59.22109986112266</c:v>
                </c:pt>
                <c:pt idx="2">
                  <c:v>67.240376511923273</c:v>
                </c:pt>
                <c:pt idx="3">
                  <c:v>81.7536529490664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59B-47D0-8571-DB78964B0C82}"/>
            </c:ext>
          </c:extLst>
        </c:ser>
        <c:ser>
          <c:idx val="1"/>
          <c:order val="1"/>
          <c:tx>
            <c:v>Donor 2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00_NKC expansion_phase'!$C$15:$F$15</c:f>
              <c:numCache>
                <c:formatCode>General</c:formatCode>
                <c:ptCount val="4"/>
                <c:pt idx="0">
                  <c:v>0.1</c:v>
                </c:pt>
                <c:pt idx="1">
                  <c:v>0.5</c:v>
                </c:pt>
                <c:pt idx="2">
                  <c:v>1</c:v>
                </c:pt>
                <c:pt idx="3">
                  <c:v>5</c:v>
                </c:pt>
              </c:numCache>
            </c:numRef>
          </c:xVal>
          <c:yVal>
            <c:numRef>
              <c:f>'00_NKC expansion_phase'!$C$17:$F$17</c:f>
              <c:numCache>
                <c:formatCode>0.00</c:formatCode>
                <c:ptCount val="4"/>
                <c:pt idx="0">
                  <c:v>5.8918657977311142</c:v>
                </c:pt>
                <c:pt idx="1">
                  <c:v>23.567463190924457</c:v>
                </c:pt>
                <c:pt idx="2">
                  <c:v>37.968863142650257</c:v>
                </c:pt>
                <c:pt idx="3">
                  <c:v>70.11103065411538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59B-47D0-8571-DB78964B0C82}"/>
            </c:ext>
          </c:extLst>
        </c:ser>
        <c:ser>
          <c:idx val="2"/>
          <c:order val="2"/>
          <c:tx>
            <c:v>Donor 3</c:v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00_NKC expansion_phase'!$C$15:$F$15</c:f>
              <c:numCache>
                <c:formatCode>General</c:formatCode>
                <c:ptCount val="4"/>
                <c:pt idx="0">
                  <c:v>0.1</c:v>
                </c:pt>
                <c:pt idx="1">
                  <c:v>0.5</c:v>
                </c:pt>
                <c:pt idx="2">
                  <c:v>1</c:v>
                </c:pt>
                <c:pt idx="3">
                  <c:v>5</c:v>
                </c:pt>
              </c:numCache>
            </c:numRef>
          </c:xVal>
          <c:yVal>
            <c:numRef>
              <c:f>'00_NKC expansion_phase'!$C$18:$F$18</c:f>
              <c:numCache>
                <c:formatCode>0.00</c:formatCode>
                <c:ptCount val="4"/>
                <c:pt idx="0">
                  <c:v>7.3292300265508112</c:v>
                </c:pt>
                <c:pt idx="1">
                  <c:v>29.485879797248373</c:v>
                </c:pt>
                <c:pt idx="2">
                  <c:v>46.401158580738603</c:v>
                </c:pt>
                <c:pt idx="3">
                  <c:v>76.19961380642047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159B-47D0-8571-DB78964B0C82}"/>
            </c:ext>
          </c:extLst>
        </c:ser>
        <c:ser>
          <c:idx val="3"/>
          <c:order val="3"/>
          <c:tx>
            <c:v>Donor 4</c:v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00_NKC expansion_phase'!$C$15:$F$15</c:f>
              <c:numCache>
                <c:formatCode>General</c:formatCode>
                <c:ptCount val="4"/>
                <c:pt idx="0">
                  <c:v>0.1</c:v>
                </c:pt>
                <c:pt idx="1">
                  <c:v>0.5</c:v>
                </c:pt>
                <c:pt idx="2">
                  <c:v>1</c:v>
                </c:pt>
                <c:pt idx="3">
                  <c:v>5</c:v>
                </c:pt>
              </c:numCache>
            </c:numRef>
          </c:xVal>
          <c:yVal>
            <c:numRef>
              <c:f>'00_NKC expansion_phase'!$C$19:$F$19</c:f>
              <c:numCache>
                <c:formatCode>0.00</c:formatCode>
                <c:ptCount val="4"/>
                <c:pt idx="0">
                  <c:v>54.70781223019808</c:v>
                </c:pt>
                <c:pt idx="1">
                  <c:v>73.890574508497991</c:v>
                </c:pt>
                <c:pt idx="2">
                  <c:v>77.950862132761046</c:v>
                </c:pt>
                <c:pt idx="3">
                  <c:v>81.0343126372135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159B-47D0-8571-DB78964B0C82}"/>
            </c:ext>
          </c:extLst>
        </c:ser>
        <c:ser>
          <c:idx val="4"/>
          <c:order val="4"/>
          <c:tx>
            <c:v>Donor 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00_NKC expansion_phase'!$C$15:$F$15</c:f>
              <c:numCache>
                <c:formatCode>General</c:formatCode>
                <c:ptCount val="4"/>
                <c:pt idx="0">
                  <c:v>0.1</c:v>
                </c:pt>
                <c:pt idx="1">
                  <c:v>0.5</c:v>
                </c:pt>
                <c:pt idx="2">
                  <c:v>1</c:v>
                </c:pt>
                <c:pt idx="3">
                  <c:v>5</c:v>
                </c:pt>
              </c:numCache>
            </c:numRef>
          </c:xVal>
          <c:yVal>
            <c:numRef>
              <c:f>'00_NKC expansion_phase'!$C$20:$F$20</c:f>
              <c:numCache>
                <c:formatCode>0.00</c:formatCode>
                <c:ptCount val="4"/>
                <c:pt idx="0">
                  <c:v>5.5917496049457966</c:v>
                </c:pt>
                <c:pt idx="1">
                  <c:v>16.396828477170022</c:v>
                </c:pt>
                <c:pt idx="2">
                  <c:v>27.537356879487675</c:v>
                </c:pt>
                <c:pt idx="3">
                  <c:v>89.9642371988578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159B-47D0-8571-DB78964B0C82}"/>
            </c:ext>
          </c:extLst>
        </c:ser>
        <c:ser>
          <c:idx val="5"/>
          <c:order val="5"/>
          <c:tx>
            <c:v>Donor 6</c:v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00_NKC expansion_phase'!$C$15:$F$15</c:f>
              <c:numCache>
                <c:formatCode>General</c:formatCode>
                <c:ptCount val="4"/>
                <c:pt idx="0">
                  <c:v>0.1</c:v>
                </c:pt>
                <c:pt idx="1">
                  <c:v>0.5</c:v>
                </c:pt>
                <c:pt idx="2">
                  <c:v>1</c:v>
                </c:pt>
                <c:pt idx="3">
                  <c:v>5</c:v>
                </c:pt>
              </c:numCache>
            </c:numRef>
          </c:xVal>
          <c:yVal>
            <c:numRef>
              <c:f>'00_NKC expansion_phase'!$C$21:$F$21</c:f>
              <c:numCache>
                <c:formatCode>0.00</c:formatCode>
                <c:ptCount val="4"/>
                <c:pt idx="0">
                  <c:v>6.8240414737600803</c:v>
                </c:pt>
                <c:pt idx="1">
                  <c:v>21.890161071220643</c:v>
                </c:pt>
                <c:pt idx="2">
                  <c:v>30.714424329794014</c:v>
                </c:pt>
                <c:pt idx="3">
                  <c:v>95.6710376756951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159B-47D0-8571-DB78964B0C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55314864"/>
        <c:axId val="1555313616"/>
      </c:scatterChart>
      <c:valAx>
        <c:axId val="1555314864"/>
        <c:scaling>
          <c:orientation val="minMax"/>
          <c:max val="5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E:T ratio 1:X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#,##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555313616"/>
        <c:crosses val="autoZero"/>
        <c:crossBetween val="midCat"/>
      </c:valAx>
      <c:valAx>
        <c:axId val="1555313616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rel. calcein release [%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555314864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/>
              <a:t>Donor 1</a:t>
            </a:r>
          </a:p>
        </c:rich>
      </c:tx>
      <c:layout>
        <c:manualLayout>
          <c:xMode val="edge"/>
          <c:yMode val="edge"/>
          <c:x val="0.41069109753620092"/>
          <c:y val="3.203202866572307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29422414774608785"/>
          <c:y val="0.19272603913876721"/>
          <c:w val="0.64786701185204254"/>
          <c:h val="0.58048719790791337"/>
        </c:manualLayout>
      </c:layout>
      <c:scatterChart>
        <c:scatterStyle val="lineMarker"/>
        <c:varyColors val="0"/>
        <c:ser>
          <c:idx val="0"/>
          <c:order val="0"/>
          <c:tx>
            <c:v>control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01_bag-test_phase'!$D$39:$G$39</c:f>
              <c:numCache>
                <c:formatCode>General</c:formatCode>
                <c:ptCount val="4"/>
                <c:pt idx="0">
                  <c:v>5</c:v>
                </c:pt>
                <c:pt idx="1">
                  <c:v>1</c:v>
                </c:pt>
                <c:pt idx="2">
                  <c:v>0.5</c:v>
                </c:pt>
                <c:pt idx="3">
                  <c:v>0.1</c:v>
                </c:pt>
              </c:numCache>
            </c:numRef>
          </c:xVal>
          <c:yVal>
            <c:numRef>
              <c:f>'01_bag-test_phase'!$D$40:$G$40</c:f>
              <c:numCache>
                <c:formatCode>0.00</c:formatCode>
                <c:ptCount val="4"/>
                <c:pt idx="0">
                  <c:v>103.99912416521995</c:v>
                </c:pt>
                <c:pt idx="1">
                  <c:v>79.43039459484821</c:v>
                </c:pt>
                <c:pt idx="2">
                  <c:v>71.981106992602307</c:v>
                </c:pt>
                <c:pt idx="3">
                  <c:v>33.17067830275731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8D1-4F3D-BC9B-475412BAC330}"/>
            </c:ext>
          </c:extLst>
        </c:ser>
        <c:ser>
          <c:idx val="1"/>
          <c:order val="1"/>
          <c:tx>
            <c:v>bag A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01_bag-test_phase'!$H$39:$K$39</c:f>
              <c:numCache>
                <c:formatCode>General</c:formatCode>
                <c:ptCount val="4"/>
                <c:pt idx="0">
                  <c:v>5</c:v>
                </c:pt>
                <c:pt idx="1">
                  <c:v>1</c:v>
                </c:pt>
                <c:pt idx="2">
                  <c:v>0.5</c:v>
                </c:pt>
                <c:pt idx="3">
                  <c:v>0.1</c:v>
                </c:pt>
              </c:numCache>
            </c:numRef>
          </c:xVal>
          <c:yVal>
            <c:numRef>
              <c:f>'01_bag-test_phase'!$H$40:$K$40</c:f>
              <c:numCache>
                <c:formatCode>0.00</c:formatCode>
                <c:ptCount val="4"/>
                <c:pt idx="0">
                  <c:v>110.69456826037316</c:v>
                </c:pt>
                <c:pt idx="1">
                  <c:v>95.960212077136021</c:v>
                </c:pt>
                <c:pt idx="2">
                  <c:v>81.208651996434099</c:v>
                </c:pt>
                <c:pt idx="3">
                  <c:v>35.13505059509844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8D1-4F3D-BC9B-475412BAC330}"/>
            </c:ext>
          </c:extLst>
        </c:ser>
        <c:ser>
          <c:idx val="2"/>
          <c:order val="2"/>
          <c:tx>
            <c:v>bag B</c:v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01_bag-test_phase'!$L$39:$O$39</c:f>
              <c:numCache>
                <c:formatCode>General</c:formatCode>
                <c:ptCount val="4"/>
                <c:pt idx="0">
                  <c:v>5</c:v>
                </c:pt>
                <c:pt idx="1">
                  <c:v>1</c:v>
                </c:pt>
                <c:pt idx="2">
                  <c:v>0.5</c:v>
                </c:pt>
                <c:pt idx="3">
                  <c:v>0.1</c:v>
                </c:pt>
              </c:numCache>
            </c:numRef>
          </c:xVal>
          <c:yVal>
            <c:numRef>
              <c:f>'01_bag-test_phase'!$L$40:$O$40</c:f>
              <c:numCache>
                <c:formatCode>0.00</c:formatCode>
                <c:ptCount val="4"/>
                <c:pt idx="0">
                  <c:v>114.82350365191822</c:v>
                </c:pt>
                <c:pt idx="1">
                  <c:v>105.75392170662661</c:v>
                </c:pt>
                <c:pt idx="2">
                  <c:v>79.10821251505341</c:v>
                </c:pt>
                <c:pt idx="3">
                  <c:v>35.60893977071896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88D1-4F3D-BC9B-475412BAC3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55314864"/>
        <c:axId val="1555313616"/>
      </c:scatterChart>
      <c:valAx>
        <c:axId val="1555314864"/>
        <c:scaling>
          <c:orientation val="minMax"/>
          <c:max val="5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E:T ratio 1:X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#,##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555313616"/>
        <c:crosses val="autoZero"/>
        <c:crossBetween val="midCat"/>
        <c:majorUnit val="1"/>
      </c:valAx>
      <c:valAx>
        <c:axId val="1555313616"/>
        <c:scaling>
          <c:orientation val="minMax"/>
          <c:max val="12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sz="900" dirty="0"/>
                  <a:t>rel. </a:t>
                </a:r>
                <a:r>
                  <a:rPr lang="de-DE" sz="900" dirty="0" err="1"/>
                  <a:t>calcein</a:t>
                </a:r>
                <a:r>
                  <a:rPr lang="de-DE" sz="900" dirty="0"/>
                  <a:t> release [%]</a:t>
                </a:r>
              </a:p>
            </c:rich>
          </c:tx>
          <c:layout>
            <c:manualLayout>
              <c:xMode val="edge"/>
              <c:yMode val="edge"/>
              <c:x val="2.777771199652675E-2"/>
              <c:y val="0.2091224863580129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55531486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/>
              <a:t>Donor 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2080811558995857"/>
          <c:y val="0.19643068306652431"/>
          <c:w val="0.72796600314673066"/>
          <c:h val="0.57242318350782606"/>
        </c:manualLayout>
      </c:layout>
      <c:scatterChart>
        <c:scatterStyle val="lineMarker"/>
        <c:varyColors val="0"/>
        <c:ser>
          <c:idx val="0"/>
          <c:order val="0"/>
          <c:tx>
            <c:v>Donor 2_control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01_bag-test_phase'!$D$39:$G$39</c:f>
              <c:numCache>
                <c:formatCode>General</c:formatCode>
                <c:ptCount val="4"/>
                <c:pt idx="0">
                  <c:v>5</c:v>
                </c:pt>
                <c:pt idx="1">
                  <c:v>1</c:v>
                </c:pt>
                <c:pt idx="2">
                  <c:v>0.5</c:v>
                </c:pt>
                <c:pt idx="3">
                  <c:v>0.1</c:v>
                </c:pt>
              </c:numCache>
            </c:numRef>
          </c:xVal>
          <c:yVal>
            <c:numRef>
              <c:f>'01_bag-test_phase'!$D$41:$G$41</c:f>
              <c:numCache>
                <c:formatCode>0.00</c:formatCode>
                <c:ptCount val="4"/>
                <c:pt idx="0">
                  <c:v>90.638277209934685</c:v>
                </c:pt>
                <c:pt idx="1">
                  <c:v>57.686518245162539</c:v>
                </c:pt>
                <c:pt idx="2">
                  <c:v>32.679841705309663</c:v>
                </c:pt>
                <c:pt idx="3">
                  <c:v>1.633931389448634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69D-4AC8-A8D7-992632604B1F}"/>
            </c:ext>
          </c:extLst>
        </c:ser>
        <c:ser>
          <c:idx val="1"/>
          <c:order val="1"/>
          <c:tx>
            <c:v>Donor 2_bag A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01_bag-test_phase'!$H$39:$K$39</c:f>
              <c:numCache>
                <c:formatCode>General</c:formatCode>
                <c:ptCount val="4"/>
                <c:pt idx="0">
                  <c:v>5</c:v>
                </c:pt>
                <c:pt idx="1">
                  <c:v>1</c:v>
                </c:pt>
                <c:pt idx="2">
                  <c:v>0.5</c:v>
                </c:pt>
                <c:pt idx="3">
                  <c:v>0.1</c:v>
                </c:pt>
              </c:numCache>
            </c:numRef>
          </c:xVal>
          <c:yVal>
            <c:numRef>
              <c:f>'01_bag-test_phase'!$H$41:$K$41</c:f>
              <c:numCache>
                <c:formatCode>0.00</c:formatCode>
                <c:ptCount val="4"/>
                <c:pt idx="0">
                  <c:v>97.322100560829355</c:v>
                </c:pt>
                <c:pt idx="1">
                  <c:v>80.839544538590403</c:v>
                </c:pt>
                <c:pt idx="2">
                  <c:v>61.839326033649762</c:v>
                </c:pt>
                <c:pt idx="3">
                  <c:v>11.17045813202553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69D-4AC8-A8D7-992632604B1F}"/>
            </c:ext>
          </c:extLst>
        </c:ser>
        <c:ser>
          <c:idx val="2"/>
          <c:order val="2"/>
          <c:tx>
            <c:v>Donor 2_bag B</c:v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01_bag-test_phase'!$L$39:$O$39</c:f>
              <c:numCache>
                <c:formatCode>General</c:formatCode>
                <c:ptCount val="4"/>
                <c:pt idx="0">
                  <c:v>5</c:v>
                </c:pt>
                <c:pt idx="1">
                  <c:v>1</c:v>
                </c:pt>
                <c:pt idx="2">
                  <c:v>0.5</c:v>
                </c:pt>
                <c:pt idx="3">
                  <c:v>0.1</c:v>
                </c:pt>
              </c:numCache>
            </c:numRef>
          </c:xVal>
          <c:yVal>
            <c:numRef>
              <c:f>'01_bag-test_phase'!$L$41:$O$41</c:f>
              <c:numCache>
                <c:formatCode>0.00</c:formatCode>
                <c:ptCount val="4"/>
                <c:pt idx="0">
                  <c:v>93.148656194615072</c:v>
                </c:pt>
                <c:pt idx="1">
                  <c:v>82.671344290951467</c:v>
                </c:pt>
                <c:pt idx="2">
                  <c:v>64.148194906407056</c:v>
                </c:pt>
                <c:pt idx="3">
                  <c:v>18.9419505207701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D69D-4AC8-A8D7-992632604B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55314864"/>
        <c:axId val="1555313616"/>
      </c:scatterChart>
      <c:valAx>
        <c:axId val="1555314864"/>
        <c:scaling>
          <c:orientation val="minMax"/>
          <c:max val="5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E:T ratio 1:X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#,##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555313616"/>
        <c:crosses val="autoZero"/>
        <c:crossBetween val="midCat"/>
        <c:majorUnit val="1"/>
      </c:valAx>
      <c:valAx>
        <c:axId val="15553136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55531486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/>
              <a:t>Donor 3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810956735854429"/>
          <c:y val="0.20007348872445568"/>
          <c:w val="0.7657662948140247"/>
          <c:h val="0.56449377440532611"/>
        </c:manualLayout>
      </c:layout>
      <c:scatterChart>
        <c:scatterStyle val="lineMarker"/>
        <c:varyColors val="0"/>
        <c:ser>
          <c:idx val="0"/>
          <c:order val="0"/>
          <c:tx>
            <c:v>Donor 3_control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01_bag-test_phase'!$D$39:$G$39</c:f>
              <c:numCache>
                <c:formatCode>General</c:formatCode>
                <c:ptCount val="4"/>
                <c:pt idx="0">
                  <c:v>5</c:v>
                </c:pt>
                <c:pt idx="1">
                  <c:v>1</c:v>
                </c:pt>
                <c:pt idx="2">
                  <c:v>0.5</c:v>
                </c:pt>
                <c:pt idx="3">
                  <c:v>0.1</c:v>
                </c:pt>
              </c:numCache>
            </c:numRef>
          </c:xVal>
          <c:yVal>
            <c:numRef>
              <c:f>'01_bag-test_phase'!$D$42:$G$42</c:f>
              <c:numCache>
                <c:formatCode>0.00</c:formatCode>
                <c:ptCount val="4"/>
                <c:pt idx="0">
                  <c:v>95.122484158391799</c:v>
                </c:pt>
                <c:pt idx="1">
                  <c:v>71.326082206414341</c:v>
                </c:pt>
                <c:pt idx="2">
                  <c:v>53.389254412585878</c:v>
                </c:pt>
                <c:pt idx="3">
                  <c:v>7.917162349170890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D1B-4799-826C-44E359075AD3}"/>
            </c:ext>
          </c:extLst>
        </c:ser>
        <c:ser>
          <c:idx val="1"/>
          <c:order val="1"/>
          <c:tx>
            <c:v>Donor 3_bag A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01_bag-test_phase'!$H$39:$K$39</c:f>
              <c:numCache>
                <c:formatCode>General</c:formatCode>
                <c:ptCount val="4"/>
                <c:pt idx="0">
                  <c:v>5</c:v>
                </c:pt>
                <c:pt idx="1">
                  <c:v>1</c:v>
                </c:pt>
                <c:pt idx="2">
                  <c:v>0.5</c:v>
                </c:pt>
                <c:pt idx="3">
                  <c:v>0.1</c:v>
                </c:pt>
              </c:numCache>
            </c:numRef>
          </c:xVal>
          <c:yVal>
            <c:numRef>
              <c:f>'01_bag-test_phase'!$H$42:$K$42</c:f>
              <c:numCache>
                <c:formatCode>0.00</c:formatCode>
                <c:ptCount val="4"/>
                <c:pt idx="0">
                  <c:v>94.286095802277302</c:v>
                </c:pt>
                <c:pt idx="1">
                  <c:v>83.718954089684146</c:v>
                </c:pt>
                <c:pt idx="2">
                  <c:v>65.721430479011374</c:v>
                </c:pt>
                <c:pt idx="3">
                  <c:v>15.3184102551652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D1B-4799-826C-44E359075AD3}"/>
            </c:ext>
          </c:extLst>
        </c:ser>
        <c:ser>
          <c:idx val="2"/>
          <c:order val="2"/>
          <c:tx>
            <c:v>Donor 3_bag B</c:v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01_bag-test_phase'!$L$39:$O$39</c:f>
              <c:numCache>
                <c:formatCode>General</c:formatCode>
                <c:ptCount val="4"/>
                <c:pt idx="0">
                  <c:v>5</c:v>
                </c:pt>
                <c:pt idx="1">
                  <c:v>1</c:v>
                </c:pt>
                <c:pt idx="2">
                  <c:v>0.5</c:v>
                </c:pt>
                <c:pt idx="3">
                  <c:v>0.1</c:v>
                </c:pt>
              </c:numCache>
            </c:numRef>
          </c:xVal>
          <c:yVal>
            <c:numRef>
              <c:f>'01_bag-test_phase'!$L$42:$O$42</c:f>
              <c:numCache>
                <c:formatCode>0.00</c:formatCode>
                <c:ptCount val="4"/>
                <c:pt idx="0">
                  <c:v>98.868629974022198</c:v>
                </c:pt>
                <c:pt idx="1">
                  <c:v>87.542790550875225</c:v>
                </c:pt>
                <c:pt idx="2">
                  <c:v>66.521401345019299</c:v>
                </c:pt>
                <c:pt idx="3">
                  <c:v>17.71225327150452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BD1B-4799-826C-44E359075A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55314864"/>
        <c:axId val="1555313616"/>
      </c:scatterChart>
      <c:valAx>
        <c:axId val="1555314864"/>
        <c:scaling>
          <c:orientation val="minMax"/>
          <c:max val="5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E:T ratio 1:X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#,##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555313616"/>
        <c:crosses val="autoZero"/>
        <c:crossBetween val="midCat"/>
        <c:majorUnit val="1"/>
      </c:valAx>
      <c:valAx>
        <c:axId val="15553136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55531486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de-DE"/>
              <a:t>Donor 4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control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02_transport_phase'!$D$80:$G$80</c:f>
              <c:numCache>
                <c:formatCode>General</c:formatCode>
                <c:ptCount val="4"/>
                <c:pt idx="0">
                  <c:v>0.1</c:v>
                </c:pt>
                <c:pt idx="1">
                  <c:v>0.5</c:v>
                </c:pt>
                <c:pt idx="2">
                  <c:v>1</c:v>
                </c:pt>
                <c:pt idx="3">
                  <c:v>5</c:v>
                </c:pt>
              </c:numCache>
            </c:numRef>
          </c:xVal>
          <c:yVal>
            <c:numRef>
              <c:f>'02_transport_phase'!$D$81:$G$81</c:f>
              <c:numCache>
                <c:formatCode>0.00</c:formatCode>
                <c:ptCount val="4"/>
                <c:pt idx="0">
                  <c:v>51.167041992316875</c:v>
                </c:pt>
                <c:pt idx="1">
                  <c:v>86.732017485759698</c:v>
                </c:pt>
                <c:pt idx="2">
                  <c:v>83.213670684858926</c:v>
                </c:pt>
                <c:pt idx="3">
                  <c:v>86.81812160551066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F95-4E3D-9B03-75B1E9880829}"/>
            </c:ext>
          </c:extLst>
        </c:ser>
        <c:ser>
          <c:idx val="1"/>
          <c:order val="1"/>
          <c:tx>
            <c:v>bag A incubator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02_transport_phase'!$H$80:$K$80</c:f>
              <c:numCache>
                <c:formatCode>General</c:formatCode>
                <c:ptCount val="4"/>
                <c:pt idx="0">
                  <c:v>0.1</c:v>
                </c:pt>
                <c:pt idx="1">
                  <c:v>0.5</c:v>
                </c:pt>
                <c:pt idx="2">
                  <c:v>1</c:v>
                </c:pt>
                <c:pt idx="3">
                  <c:v>5</c:v>
                </c:pt>
              </c:numCache>
            </c:numRef>
          </c:xVal>
          <c:yVal>
            <c:numRef>
              <c:f>'02_transport_phase'!$H$81:$K$81</c:f>
              <c:numCache>
                <c:formatCode>0.00</c:formatCode>
                <c:ptCount val="4"/>
                <c:pt idx="0">
                  <c:v>51.531328652801704</c:v>
                </c:pt>
                <c:pt idx="1">
                  <c:v>83.429593323619031</c:v>
                </c:pt>
                <c:pt idx="2">
                  <c:v>86.914823155384809</c:v>
                </c:pt>
                <c:pt idx="3">
                  <c:v>95.15035103987283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F95-4E3D-9B03-75B1E9880829}"/>
            </c:ext>
          </c:extLst>
        </c:ser>
        <c:ser>
          <c:idx val="2"/>
          <c:order val="2"/>
          <c:tx>
            <c:v>bag A in Cellbox</c:v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02_transport_phase'!$L$80:$O$80</c:f>
              <c:numCache>
                <c:formatCode>General</c:formatCode>
                <c:ptCount val="4"/>
                <c:pt idx="0">
                  <c:v>0.1</c:v>
                </c:pt>
                <c:pt idx="1">
                  <c:v>0.5</c:v>
                </c:pt>
                <c:pt idx="2">
                  <c:v>1</c:v>
                </c:pt>
                <c:pt idx="3">
                  <c:v>5</c:v>
                </c:pt>
              </c:numCache>
            </c:numRef>
          </c:xVal>
          <c:yVal>
            <c:numRef>
              <c:f>'02_transport_phase'!$L$81:$O$81</c:f>
              <c:numCache>
                <c:formatCode>0.00</c:formatCode>
                <c:ptCount val="4"/>
                <c:pt idx="0">
                  <c:v>47.920254338322962</c:v>
                </c:pt>
                <c:pt idx="1">
                  <c:v>70.520598754801966</c:v>
                </c:pt>
                <c:pt idx="2">
                  <c:v>79.33368658100413</c:v>
                </c:pt>
                <c:pt idx="3">
                  <c:v>76.0339117763942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BF95-4E3D-9B03-75B1E98808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55314864"/>
        <c:axId val="1555313616"/>
      </c:scatterChart>
      <c:valAx>
        <c:axId val="1555314864"/>
        <c:scaling>
          <c:orientation val="minMax"/>
          <c:max val="5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E:T ratio 1:X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#,##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555313616"/>
        <c:crosses val="autoZero"/>
        <c:crossBetween val="midCat"/>
        <c:majorUnit val="1"/>
      </c:valAx>
      <c:valAx>
        <c:axId val="1555313616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rel. calcein release [%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55531486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de-DE"/>
              <a:t>Donor 5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control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02_transport_phase'!$H$80:$K$80</c:f>
              <c:numCache>
                <c:formatCode>General</c:formatCode>
                <c:ptCount val="4"/>
                <c:pt idx="0">
                  <c:v>0.1</c:v>
                </c:pt>
                <c:pt idx="1">
                  <c:v>0.5</c:v>
                </c:pt>
                <c:pt idx="2">
                  <c:v>1</c:v>
                </c:pt>
                <c:pt idx="3">
                  <c:v>5</c:v>
                </c:pt>
              </c:numCache>
            </c:numRef>
          </c:xVal>
          <c:yVal>
            <c:numRef>
              <c:f>'02_transport_phase'!$D$82:$G$82</c:f>
              <c:numCache>
                <c:formatCode>0.00</c:formatCode>
                <c:ptCount val="4"/>
                <c:pt idx="0">
                  <c:v>13.911257701163736</c:v>
                </c:pt>
                <c:pt idx="1">
                  <c:v>51.10212209845043</c:v>
                </c:pt>
                <c:pt idx="2">
                  <c:v>66.504449561267037</c:v>
                </c:pt>
                <c:pt idx="3">
                  <c:v>75.63133984691019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C06-4219-A25C-26D4F21EB185}"/>
            </c:ext>
          </c:extLst>
        </c:ser>
        <c:ser>
          <c:idx val="1"/>
          <c:order val="1"/>
          <c:tx>
            <c:v>bag A incubator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02_transport_phase'!$H$80:$K$80</c:f>
              <c:numCache>
                <c:formatCode>General</c:formatCode>
                <c:ptCount val="4"/>
                <c:pt idx="0">
                  <c:v>0.1</c:v>
                </c:pt>
                <c:pt idx="1">
                  <c:v>0.5</c:v>
                </c:pt>
                <c:pt idx="2">
                  <c:v>1</c:v>
                </c:pt>
                <c:pt idx="3">
                  <c:v>5</c:v>
                </c:pt>
              </c:numCache>
            </c:numRef>
          </c:xVal>
          <c:yVal>
            <c:numRef>
              <c:f>'02_transport_phase'!$H$82:$K$82</c:f>
              <c:numCache>
                <c:formatCode>0.00</c:formatCode>
                <c:ptCount val="4"/>
                <c:pt idx="0">
                  <c:v>13.649884871491698</c:v>
                </c:pt>
                <c:pt idx="1">
                  <c:v>43.944240463003297</c:v>
                </c:pt>
                <c:pt idx="2">
                  <c:v>62.648578007343332</c:v>
                </c:pt>
                <c:pt idx="3">
                  <c:v>78.56244943680378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C06-4219-A25C-26D4F21EB185}"/>
            </c:ext>
          </c:extLst>
        </c:ser>
        <c:ser>
          <c:idx val="2"/>
          <c:order val="2"/>
          <c:tx>
            <c:v>bag A in Cellbox</c:v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02_transport_phase'!$L$80:$O$80</c:f>
              <c:numCache>
                <c:formatCode>General</c:formatCode>
                <c:ptCount val="4"/>
                <c:pt idx="0">
                  <c:v>0.1</c:v>
                </c:pt>
                <c:pt idx="1">
                  <c:v>0.5</c:v>
                </c:pt>
                <c:pt idx="2">
                  <c:v>1</c:v>
                </c:pt>
                <c:pt idx="3">
                  <c:v>5</c:v>
                </c:pt>
              </c:numCache>
            </c:numRef>
          </c:xVal>
          <c:yVal>
            <c:numRef>
              <c:f>'02_transport_phase'!$L$82:$O$82</c:f>
              <c:numCache>
                <c:formatCode>0.00</c:formatCode>
                <c:ptCount val="4"/>
                <c:pt idx="0">
                  <c:v>15.785674279668932</c:v>
                </c:pt>
                <c:pt idx="1">
                  <c:v>51.088431140705715</c:v>
                </c:pt>
                <c:pt idx="2">
                  <c:v>63.900678324724623</c:v>
                </c:pt>
                <c:pt idx="3">
                  <c:v>71.65100504076171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CC06-4219-A25C-26D4F21EB1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55314864"/>
        <c:axId val="1555313616"/>
      </c:scatterChart>
      <c:valAx>
        <c:axId val="1555314864"/>
        <c:scaling>
          <c:orientation val="minMax"/>
          <c:max val="5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E:T ratio 1:X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#,##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555313616"/>
        <c:crosses val="autoZero"/>
        <c:crossBetween val="midCat"/>
        <c:majorUnit val="1"/>
      </c:valAx>
      <c:valAx>
        <c:axId val="1555313616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55531486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de-DE"/>
              <a:t>Donor 6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control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02_transport_phase'!$H$80:$K$80</c:f>
              <c:numCache>
                <c:formatCode>General</c:formatCode>
                <c:ptCount val="4"/>
                <c:pt idx="0">
                  <c:v>0.1</c:v>
                </c:pt>
                <c:pt idx="1">
                  <c:v>0.5</c:v>
                </c:pt>
                <c:pt idx="2">
                  <c:v>1</c:v>
                </c:pt>
                <c:pt idx="3">
                  <c:v>5</c:v>
                </c:pt>
              </c:numCache>
            </c:numRef>
          </c:xVal>
          <c:yVal>
            <c:numRef>
              <c:f>'02_transport_phase'!$D$83:$G$83</c:f>
              <c:numCache>
                <c:formatCode>0.00</c:formatCode>
                <c:ptCount val="4"/>
                <c:pt idx="0">
                  <c:v>10.12052346163536</c:v>
                </c:pt>
                <c:pt idx="1">
                  <c:v>39.414751859561669</c:v>
                </c:pt>
                <c:pt idx="2">
                  <c:v>60.199413956325166</c:v>
                </c:pt>
                <c:pt idx="3">
                  <c:v>76.6298511024780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0B3-4BEF-94BA-4160BEC465F5}"/>
            </c:ext>
          </c:extLst>
        </c:ser>
        <c:ser>
          <c:idx val="1"/>
          <c:order val="1"/>
          <c:tx>
            <c:v>bag A incubator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02_transport_phase'!$H$80:$K$80</c:f>
              <c:numCache>
                <c:formatCode>General</c:formatCode>
                <c:ptCount val="4"/>
                <c:pt idx="0">
                  <c:v>0.1</c:v>
                </c:pt>
                <c:pt idx="1">
                  <c:v>0.5</c:v>
                </c:pt>
                <c:pt idx="2">
                  <c:v>1</c:v>
                </c:pt>
                <c:pt idx="3">
                  <c:v>5</c:v>
                </c:pt>
              </c:numCache>
            </c:numRef>
          </c:xVal>
          <c:yVal>
            <c:numRef>
              <c:f>'02_transport_phase'!$H$83:$K$83</c:f>
              <c:numCache>
                <c:formatCode>0.00</c:formatCode>
                <c:ptCount val="4"/>
                <c:pt idx="0">
                  <c:v>18.61683085612761</c:v>
                </c:pt>
                <c:pt idx="1">
                  <c:v>59.562986436138488</c:v>
                </c:pt>
                <c:pt idx="2">
                  <c:v>73.991328675037451</c:v>
                </c:pt>
                <c:pt idx="3">
                  <c:v>80.05993025815092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0B3-4BEF-94BA-4160BEC465F5}"/>
            </c:ext>
          </c:extLst>
        </c:ser>
        <c:ser>
          <c:idx val="2"/>
          <c:order val="2"/>
          <c:tx>
            <c:v>bag A in Cellbox</c:v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02_transport_phase'!$L$80:$O$80</c:f>
              <c:numCache>
                <c:formatCode>General</c:formatCode>
                <c:ptCount val="4"/>
                <c:pt idx="0">
                  <c:v>0.1</c:v>
                </c:pt>
                <c:pt idx="1">
                  <c:v>0.5</c:v>
                </c:pt>
                <c:pt idx="2">
                  <c:v>1</c:v>
                </c:pt>
                <c:pt idx="3">
                  <c:v>5</c:v>
                </c:pt>
              </c:numCache>
            </c:numRef>
          </c:xVal>
          <c:yVal>
            <c:numRef>
              <c:f>'02_transport_phase'!$L$83:$O$83</c:f>
              <c:numCache>
                <c:formatCode>0.00</c:formatCode>
                <c:ptCount val="4"/>
                <c:pt idx="0">
                  <c:v>15.213269513795899</c:v>
                </c:pt>
                <c:pt idx="1">
                  <c:v>52.074355948608492</c:v>
                </c:pt>
                <c:pt idx="2">
                  <c:v>69.577438644409384</c:v>
                </c:pt>
                <c:pt idx="3">
                  <c:v>79.8080110314103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70B3-4BEF-94BA-4160BEC465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55314864"/>
        <c:axId val="1555313616"/>
      </c:scatterChart>
      <c:valAx>
        <c:axId val="1555314864"/>
        <c:scaling>
          <c:orientation val="minMax"/>
          <c:max val="5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E:T ratio 1:X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#,##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555313616"/>
        <c:crosses val="autoZero"/>
        <c:crossBetween val="midCat"/>
        <c:majorUnit val="1"/>
      </c:valAx>
      <c:valAx>
        <c:axId val="1555313616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55531486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v>Cellbox (bag A)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02_transport_phase'!$H$52:$K$52</c:f>
              <c:numCache>
                <c:formatCode>General</c:formatCode>
                <c:ptCount val="4"/>
                <c:pt idx="0">
                  <c:v>0.1</c:v>
                </c:pt>
                <c:pt idx="1">
                  <c:v>0.5</c:v>
                </c:pt>
                <c:pt idx="2">
                  <c:v>1</c:v>
                </c:pt>
                <c:pt idx="3">
                  <c:v>5</c:v>
                </c:pt>
              </c:numCache>
            </c:numRef>
          </c:xVal>
          <c:yVal>
            <c:numRef>
              <c:f>'02_transport_phase'!$H$53:$K$53</c:f>
              <c:numCache>
                <c:formatCode>0.00</c:formatCode>
                <c:ptCount val="4"/>
                <c:pt idx="0">
                  <c:v>47.920254338322962</c:v>
                </c:pt>
                <c:pt idx="1">
                  <c:v>70.520598754801966</c:v>
                </c:pt>
                <c:pt idx="2">
                  <c:v>79.33368658100413</c:v>
                </c:pt>
                <c:pt idx="3">
                  <c:v>76.0339117763942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876-4EA8-91DB-89B2330893AB}"/>
            </c:ext>
          </c:extLst>
        </c:ser>
        <c:ser>
          <c:idx val="1"/>
          <c:order val="1"/>
          <c:tx>
            <c:v>CRF (14 x 1 mL vials)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02_transport_phase'!$L$52:$O$52</c:f>
              <c:numCache>
                <c:formatCode>General</c:formatCode>
                <c:ptCount val="4"/>
                <c:pt idx="0">
                  <c:v>0.1</c:v>
                </c:pt>
                <c:pt idx="1">
                  <c:v>0.5</c:v>
                </c:pt>
                <c:pt idx="2">
                  <c:v>1</c:v>
                </c:pt>
                <c:pt idx="3">
                  <c:v>5</c:v>
                </c:pt>
              </c:numCache>
            </c:numRef>
          </c:xVal>
          <c:yVal>
            <c:numRef>
              <c:f>'02_transport_phase'!$L$53:$O$53</c:f>
              <c:numCache>
                <c:formatCode>0.00</c:formatCode>
                <c:ptCount val="4"/>
                <c:pt idx="0">
                  <c:v>18.072592396343889</c:v>
                </c:pt>
                <c:pt idx="1">
                  <c:v>50.683534242946088</c:v>
                </c:pt>
                <c:pt idx="2">
                  <c:v>72.934163465359646</c:v>
                </c:pt>
                <c:pt idx="3">
                  <c:v>73.83229566830044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876-4EA8-91DB-89B2330893A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55314864"/>
        <c:axId val="1555313616"/>
      </c:scatterChart>
      <c:valAx>
        <c:axId val="1555314864"/>
        <c:scaling>
          <c:orientation val="minMax"/>
          <c:max val="5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E:T ratio 1:X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#,##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555313616"/>
        <c:crosses val="autoZero"/>
        <c:crossBetween val="midCat"/>
      </c:valAx>
      <c:valAx>
        <c:axId val="1555313616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rel. calcein release [%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555314864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v>Cellbox (bag A into 1 x G-Rex 24)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03_recultivation_phase'!$D$30:$G$30</c:f>
              <c:numCache>
                <c:formatCode>General</c:formatCode>
                <c:ptCount val="4"/>
                <c:pt idx="0">
                  <c:v>0.1</c:v>
                </c:pt>
                <c:pt idx="1">
                  <c:v>0.5</c:v>
                </c:pt>
                <c:pt idx="2">
                  <c:v>1</c:v>
                </c:pt>
                <c:pt idx="3">
                  <c:v>5</c:v>
                </c:pt>
              </c:numCache>
            </c:numRef>
          </c:xVal>
          <c:yVal>
            <c:numRef>
              <c:f>'03_recultivation_phase'!$D$31:$G$31</c:f>
              <c:numCache>
                <c:formatCode>0.00</c:formatCode>
                <c:ptCount val="4"/>
                <c:pt idx="0">
                  <c:v>26.526573690162081</c:v>
                </c:pt>
                <c:pt idx="1">
                  <c:v>68.497926875235592</c:v>
                </c:pt>
                <c:pt idx="2">
                  <c:v>79.631549189596683</c:v>
                </c:pt>
                <c:pt idx="3">
                  <c:v>90.64266867696949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F3B-4F67-8139-AD1072E9B6AE}"/>
            </c:ext>
          </c:extLst>
        </c:ser>
        <c:ser>
          <c:idx val="1"/>
          <c:order val="1"/>
          <c:tx>
            <c:v>CRF (14 x 1 mL vial into 1 x G-Rex 24)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03_recultivation_phase'!$H$30:$K$30</c:f>
              <c:numCache>
                <c:formatCode>General</c:formatCode>
                <c:ptCount val="4"/>
                <c:pt idx="0">
                  <c:v>0.1</c:v>
                </c:pt>
                <c:pt idx="1">
                  <c:v>0.5</c:v>
                </c:pt>
                <c:pt idx="2">
                  <c:v>1</c:v>
                </c:pt>
                <c:pt idx="3">
                  <c:v>5</c:v>
                </c:pt>
              </c:numCache>
            </c:numRef>
          </c:xVal>
          <c:yVal>
            <c:numRef>
              <c:f>'03_recultivation_phase'!$H$31:$K$31</c:f>
              <c:numCache>
                <c:formatCode>0.00</c:formatCode>
                <c:ptCount val="4"/>
                <c:pt idx="0">
                  <c:v>13.855776479457219</c:v>
                </c:pt>
                <c:pt idx="1">
                  <c:v>52.260412740294008</c:v>
                </c:pt>
                <c:pt idx="2">
                  <c:v>72.316716924236729</c:v>
                </c:pt>
                <c:pt idx="3">
                  <c:v>89.7674802110818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F3B-4F67-8139-AD1072E9B6A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55314864"/>
        <c:axId val="1555313616"/>
      </c:scatterChart>
      <c:valAx>
        <c:axId val="1555314864"/>
        <c:scaling>
          <c:orientation val="minMax"/>
          <c:max val="5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E:T ratio 1:X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#,##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555313616"/>
        <c:crosses val="autoZero"/>
        <c:crossBetween val="midCat"/>
      </c:valAx>
      <c:valAx>
        <c:axId val="1555313616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555314864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720438-76E9-46F8-964D-7D6099CE7084}" type="datetimeFigureOut">
              <a:rPr lang="de-DE" smtClean="0"/>
              <a:t>10.04.20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5B1FD8-6299-4AD8-9F1F-8B75B11C93B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87359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9A0812-1549-429D-B520-D5A70A301F10}" type="datetime1">
              <a:rPr lang="de-DE" smtClean="0"/>
              <a:t>10.04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92785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7873C-DB84-4E4E-B37C-7852F7F06B78}" type="datetime1">
              <a:rPr lang="de-DE" smtClean="0"/>
              <a:t>10.04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7199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5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5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6E2D-45E0-4F86-9A12-405D29F6BFBC}" type="datetime1">
              <a:rPr lang="de-DE" smtClean="0"/>
              <a:t>10.04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018733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97873-588F-4D4E-A307-9802EB68A555}" type="datetime1">
              <a:rPr lang="de-DE" smtClean="0"/>
              <a:t>10.04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809092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263E2-A8DD-4DFA-8B64-BFF2B4D73BDD}" type="datetime1">
              <a:rPr lang="de-DE" smtClean="0"/>
              <a:t>10.04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88906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09A4D9-D3F4-4D84-AB33-DFDD4AA40789}" type="datetime1">
              <a:rPr lang="de-DE" smtClean="0"/>
              <a:t>10.04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63754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9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4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9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DB409-0898-4735-8DCC-E53841FB96BC}" type="datetime1">
              <a:rPr lang="de-DE" smtClean="0"/>
              <a:t>10.04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48919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5625AF-1666-4C3E-A40C-B19FBA4A2600}" type="datetime1">
              <a:rPr lang="de-DE" smtClean="0"/>
              <a:t>10.04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9701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B50EB6-1FE4-4B7E-BAB5-78BFA6C2AC69}" type="datetime1">
              <a:rPr lang="de-DE" smtClean="0"/>
              <a:t>10.04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083201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5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531E3-7A1C-4C1E-9B7E-7F3221FFD598}" type="datetime1">
              <a:rPr lang="de-DE" smtClean="0"/>
              <a:t>10.04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728614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5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9FF179-BF33-426F-9C49-B111CF480FE2}" type="datetime1">
              <a:rPr lang="de-DE" smtClean="0"/>
              <a:t>10.04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2393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4C0B34-E21A-4874-89B1-2D26B2491B41}" type="datetime1">
              <a:rPr lang="de-DE" smtClean="0"/>
              <a:t>10.04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9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7443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.png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7" Type="http://schemas.openxmlformats.org/officeDocument/2006/relationships/chart" Target="../charts/chart9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8.xml"/><Relationship Id="rId5" Type="http://schemas.openxmlformats.org/officeDocument/2006/relationships/image" Target="../media/image2.png"/><Relationship Id="rId4" Type="http://schemas.openxmlformats.org/officeDocument/2006/relationships/chart" Target="../charts/char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87E1FED3-298C-4BC8-A013-88EEEC03E975}"/>
              </a:ext>
            </a:extLst>
          </p:cNvPr>
          <p:cNvSpPr txBox="1"/>
          <p:nvPr/>
        </p:nvSpPr>
        <p:spPr>
          <a:xfrm>
            <a:off x="105340" y="4619616"/>
            <a:ext cx="6494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1: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ytotoxicit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ompariso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1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6 after NK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expansio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up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21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Foliennummernplatzhalter 1">
            <a:extLst>
              <a:ext uri="{FF2B5EF4-FFF2-40B4-BE49-F238E27FC236}">
                <a16:creationId xmlns:a16="http://schemas.microsoft.com/office/drawing/2014/main" id="{8E788002-11E4-44BB-ACDE-7C2E486D6F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1</a:t>
            </a:fld>
            <a:endParaRPr lang="de-DE"/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43E1DBD6-14A1-4ABA-92C0-D12D9A05996C}"/>
              </a:ext>
            </a:extLst>
          </p:cNvPr>
          <p:cNvSpPr txBox="1"/>
          <p:nvPr/>
        </p:nvSpPr>
        <p:spPr>
          <a:xfrm>
            <a:off x="289129" y="-1200"/>
            <a:ext cx="63872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e-DE" sz="18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800" b="1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8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1800" b="1" u="sng" dirty="0">
                <a:latin typeface="Arial" panose="020B0604020202020204" pitchFamily="34" charset="0"/>
                <a:cs typeface="Arial" panose="020B0604020202020204" pitchFamily="34" charset="0"/>
              </a:rPr>
              <a:t> 06: </a:t>
            </a:r>
            <a:r>
              <a:rPr lang="de-DE" sz="18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Cytotoxicity</a:t>
            </a:r>
            <a:endParaRPr lang="de-DE" sz="18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4">
            <a:extLst>
              <a:ext uri="{FF2B5EF4-FFF2-40B4-BE49-F238E27FC236}">
                <a16:creationId xmlns:a16="http://schemas.microsoft.com/office/drawing/2014/main" id="{BD9228E1-BA91-40E9-8782-57D3C09BFD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9129" y="8249256"/>
            <a:ext cx="6097384" cy="43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de-DE" sz="1100" b="1" i="0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rial" panose="020B0604020202020204" pitchFamily="34" charset="0"/>
              </a:rPr>
              <a:t>Figure 2: </a:t>
            </a:r>
            <a:r>
              <a:rPr kumimoji="0" lang="en-US" altLang="de-DE" sz="1100" b="0" i="0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rial" panose="020B0604020202020204" pitchFamily="34" charset="0"/>
              </a:rPr>
              <a:t>Cytotoxicity comparison of control, </a:t>
            </a:r>
            <a:r>
              <a:rPr lang="en-US" altLang="de-DE" sz="1100" dirty="0">
                <a:latin typeface="Arial" panose="020B0604020202020204" pitchFamily="34" charset="0"/>
                <a:ea typeface="Arial" panose="020B0604020202020204" pitchFamily="34" charset="0"/>
              </a:rPr>
              <a:t>bag A and bag B in incubator </a:t>
            </a:r>
            <a:r>
              <a:rPr kumimoji="0" lang="en-US" altLang="de-DE" sz="1100" b="0" i="0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rial" panose="020B0604020202020204" pitchFamily="34" charset="0"/>
              </a:rPr>
              <a:t>after 3 d bag test phase of Donor 1 - </a:t>
            </a:r>
            <a:r>
              <a:rPr lang="en-US" altLang="de-DE" sz="1100" dirty="0">
                <a:latin typeface="Arial" panose="020B0604020202020204" pitchFamily="34" charset="0"/>
                <a:ea typeface="Arial" panose="020B0604020202020204" pitchFamily="34" charset="0"/>
              </a:rPr>
              <a:t>3</a:t>
            </a:r>
            <a:endParaRPr kumimoji="0" lang="de-DE" altLang="de-DE" sz="1100" b="0" i="0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5" name="Rectangle 2">
            <a:extLst>
              <a:ext uri="{FF2B5EF4-FFF2-40B4-BE49-F238E27FC236}">
                <a16:creationId xmlns:a16="http://schemas.microsoft.com/office/drawing/2014/main" id="{C28609E0-2500-41E8-8E61-5A50E3B932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/>
          </a:p>
        </p:txBody>
      </p:sp>
      <p:graphicFrame>
        <p:nvGraphicFramePr>
          <p:cNvPr id="11" name="Diagramm 10">
            <a:extLst>
              <a:ext uri="{FF2B5EF4-FFF2-40B4-BE49-F238E27FC236}">
                <a16:creationId xmlns:a16="http://schemas.microsoft.com/office/drawing/2014/main" id="{CE7367C6-DD9A-46F7-A7C0-BAFFD9E94DE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24377894"/>
              </p:ext>
            </p:extLst>
          </p:nvPr>
        </p:nvGraphicFramePr>
        <p:xfrm>
          <a:off x="766761" y="752466"/>
          <a:ext cx="5172075" cy="38671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5" name="Diagramm 14">
            <a:extLst>
              <a:ext uri="{FF2B5EF4-FFF2-40B4-BE49-F238E27FC236}">
                <a16:creationId xmlns:a16="http://schemas.microsoft.com/office/drawing/2014/main" id="{D7C783E4-1C59-4915-93D3-6387E3AF129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02992067"/>
              </p:ext>
            </p:extLst>
          </p:nvPr>
        </p:nvGraphicFramePr>
        <p:xfrm>
          <a:off x="0" y="5813369"/>
          <a:ext cx="2482851" cy="23788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" name="Diagramm 15">
            <a:extLst>
              <a:ext uri="{FF2B5EF4-FFF2-40B4-BE49-F238E27FC236}">
                <a16:creationId xmlns:a16="http://schemas.microsoft.com/office/drawing/2014/main" id="{67CC3378-935C-49EC-AB95-F5A6E22386A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99489599"/>
              </p:ext>
            </p:extLst>
          </p:nvPr>
        </p:nvGraphicFramePr>
        <p:xfrm>
          <a:off x="2374902" y="5840046"/>
          <a:ext cx="2259012" cy="23521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7" name="Diagramm 16">
            <a:extLst>
              <a:ext uri="{FF2B5EF4-FFF2-40B4-BE49-F238E27FC236}">
                <a16:creationId xmlns:a16="http://schemas.microsoft.com/office/drawing/2014/main" id="{06534C56-76E4-4930-811D-6358E85A18A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36803337"/>
              </p:ext>
            </p:extLst>
          </p:nvPr>
        </p:nvGraphicFramePr>
        <p:xfrm>
          <a:off x="4633914" y="5870387"/>
          <a:ext cx="2259012" cy="23788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pic>
        <p:nvPicPr>
          <p:cNvPr id="18" name="Grafik 17">
            <a:extLst>
              <a:ext uri="{FF2B5EF4-FFF2-40B4-BE49-F238E27FC236}">
                <a16:creationId xmlns:a16="http://schemas.microsoft.com/office/drawing/2014/main" id="{0A0319E0-E07F-4E5E-94E3-1C21479F07C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95132" y="5467958"/>
            <a:ext cx="2467319" cy="3143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4738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nummernplatzhalter 1">
            <a:extLst>
              <a:ext uri="{FF2B5EF4-FFF2-40B4-BE49-F238E27FC236}">
                <a16:creationId xmlns:a16="http://schemas.microsoft.com/office/drawing/2014/main" id="{8E788002-11E4-44BB-ACDE-7C2E486D6F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4826000" y="9311187"/>
            <a:ext cx="1543050" cy="527403"/>
          </a:xfrm>
        </p:spPr>
        <p:txBody>
          <a:bodyPr/>
          <a:lstStyle/>
          <a:p>
            <a:fld id="{7CA16D49-2449-4109-BE83-049B41A6F977}" type="slidenum">
              <a:rPr lang="de-DE" smtClean="0"/>
              <a:t>2</a:t>
            </a:fld>
            <a:endParaRPr lang="de-DE"/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43E1DBD6-14A1-4ABA-92C0-D12D9A05996C}"/>
              </a:ext>
            </a:extLst>
          </p:cNvPr>
          <p:cNvSpPr txBox="1"/>
          <p:nvPr/>
        </p:nvSpPr>
        <p:spPr>
          <a:xfrm>
            <a:off x="289129" y="-1200"/>
            <a:ext cx="63872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e-DE" sz="18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800" b="1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8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1800" b="1" u="sng" dirty="0">
                <a:latin typeface="Arial" panose="020B0604020202020204" pitchFamily="34" charset="0"/>
                <a:cs typeface="Arial" panose="020B0604020202020204" pitchFamily="34" charset="0"/>
              </a:rPr>
              <a:t> 06: </a:t>
            </a:r>
            <a:r>
              <a:rPr lang="de-DE" sz="18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Cytotoxicity</a:t>
            </a:r>
            <a:endParaRPr lang="de-DE" sz="18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4">
            <a:extLst>
              <a:ext uri="{FF2B5EF4-FFF2-40B4-BE49-F238E27FC236}">
                <a16:creationId xmlns:a16="http://schemas.microsoft.com/office/drawing/2014/main" id="{BD9228E1-BA91-40E9-8782-57D3C09BFD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382" y="4496354"/>
            <a:ext cx="6097384" cy="43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de-DE" sz="1100" b="1" i="0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rial" panose="020B0604020202020204" pitchFamily="34" charset="0"/>
              </a:rPr>
              <a:t>Figure 3: </a:t>
            </a:r>
            <a:r>
              <a:rPr kumimoji="0" lang="en-US" altLang="de-DE" sz="1100" b="0" i="0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rial" panose="020B0604020202020204" pitchFamily="34" charset="0"/>
              </a:rPr>
              <a:t>Cytotoxicity comparison of control, b</a:t>
            </a:r>
            <a:r>
              <a:rPr lang="en-US" altLang="de-DE" sz="1100" dirty="0">
                <a:latin typeface="Arial" panose="020B0604020202020204" pitchFamily="34" charset="0"/>
                <a:ea typeface="Arial" panose="020B0604020202020204" pitchFamily="34" charset="0"/>
              </a:rPr>
              <a:t>ag A in incubator and bag A in </a:t>
            </a:r>
            <a:r>
              <a:rPr kumimoji="0" lang="en-US" altLang="de-DE" sz="1100" b="0" i="0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rial" panose="020B0604020202020204" pitchFamily="34" charset="0"/>
              </a:rPr>
              <a:t>Cellbox™ after shipment of Donor 4 - 6</a:t>
            </a:r>
            <a:endParaRPr kumimoji="0" lang="de-DE" altLang="de-DE" sz="1100" b="0" i="0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5" name="Rectangle 2">
            <a:extLst>
              <a:ext uri="{FF2B5EF4-FFF2-40B4-BE49-F238E27FC236}">
                <a16:creationId xmlns:a16="http://schemas.microsoft.com/office/drawing/2014/main" id="{C28609E0-2500-41E8-8E61-5A50E3B932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/>
          </a:p>
        </p:txBody>
      </p:sp>
      <p:graphicFrame>
        <p:nvGraphicFramePr>
          <p:cNvPr id="13" name="Diagramm 12">
            <a:extLst>
              <a:ext uri="{FF2B5EF4-FFF2-40B4-BE49-F238E27FC236}">
                <a16:creationId xmlns:a16="http://schemas.microsoft.com/office/drawing/2014/main" id="{F2E061B9-2BB8-4804-8F25-F5725491BAD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37155051"/>
              </p:ext>
            </p:extLst>
          </p:nvPr>
        </p:nvGraphicFramePr>
        <p:xfrm>
          <a:off x="-160337" y="715520"/>
          <a:ext cx="2674937" cy="3462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4" name="Diagramm 13">
            <a:extLst>
              <a:ext uri="{FF2B5EF4-FFF2-40B4-BE49-F238E27FC236}">
                <a16:creationId xmlns:a16="http://schemas.microsoft.com/office/drawing/2014/main" id="{BC498234-5829-46B2-89B7-2706DAF1B4B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53809121"/>
              </p:ext>
            </p:extLst>
          </p:nvPr>
        </p:nvGraphicFramePr>
        <p:xfrm>
          <a:off x="2258445" y="715520"/>
          <a:ext cx="2448617" cy="3462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5" name="Diagramm 14">
            <a:extLst>
              <a:ext uri="{FF2B5EF4-FFF2-40B4-BE49-F238E27FC236}">
                <a16:creationId xmlns:a16="http://schemas.microsoft.com/office/drawing/2014/main" id="{42B080AF-6E91-46A7-BF3E-5C3E33D643C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01979680"/>
              </p:ext>
            </p:extLst>
          </p:nvPr>
        </p:nvGraphicFramePr>
        <p:xfrm>
          <a:off x="4525963" y="702631"/>
          <a:ext cx="2332037" cy="3462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16" name="Grafik 15">
            <a:extLst>
              <a:ext uri="{FF2B5EF4-FFF2-40B4-BE49-F238E27FC236}">
                <a16:creationId xmlns:a16="http://schemas.microsoft.com/office/drawing/2014/main" id="{1AFF59E7-E1BD-4D7B-B743-AAEC953C67B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67940" y="4148105"/>
            <a:ext cx="3439005" cy="238158"/>
          </a:xfrm>
          <a:prstGeom prst="rect">
            <a:avLst/>
          </a:prstGeom>
        </p:spPr>
      </p:pic>
      <p:sp>
        <p:nvSpPr>
          <p:cNvPr id="17" name="Textfeld 16">
            <a:extLst>
              <a:ext uri="{FF2B5EF4-FFF2-40B4-BE49-F238E27FC236}">
                <a16:creationId xmlns:a16="http://schemas.microsoft.com/office/drawing/2014/main" id="{99392F79-B39C-441B-9457-0BB89C7362EE}"/>
              </a:ext>
            </a:extLst>
          </p:cNvPr>
          <p:cNvSpPr txBox="1"/>
          <p:nvPr/>
        </p:nvSpPr>
        <p:spPr>
          <a:xfrm>
            <a:off x="-44309" y="5297255"/>
            <a:ext cx="2782749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) Cytotoxicity of NK cells from Cellbox™ system after shipment and thawed NK cells</a:t>
            </a:r>
            <a:endParaRPr lang="en-US" sz="1100" dirty="0">
              <a:highlight>
                <a:srgbClr val="FF00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9C356060-8F8D-4AAE-B3BE-FC90672B38E0}"/>
              </a:ext>
            </a:extLst>
          </p:cNvPr>
          <p:cNvSpPr txBox="1"/>
          <p:nvPr/>
        </p:nvSpPr>
        <p:spPr>
          <a:xfrm>
            <a:off x="3529709" y="5297255"/>
            <a:ext cx="2782749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) Cytotoxicity of NK cells from Cellbox™ system and thawed NK cells after 3 days of recultivation </a:t>
            </a:r>
            <a:endParaRPr lang="en-US" sz="1100" dirty="0">
              <a:highlight>
                <a:srgbClr val="FF00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4C5B4CB9-B1C7-4871-8199-E6B0338946CA}"/>
              </a:ext>
            </a:extLst>
          </p:cNvPr>
          <p:cNvSpPr txBox="1"/>
          <p:nvPr/>
        </p:nvSpPr>
        <p:spPr>
          <a:xfrm>
            <a:off x="181460" y="9407703"/>
            <a:ext cx="649492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4: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ytotoxicit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ompariso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NK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port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in Cellbox™ and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haw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efor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nd after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cultivatio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ve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3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in G-Rex® 24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4</a:t>
            </a:r>
          </a:p>
        </p:txBody>
      </p:sp>
      <p:graphicFrame>
        <p:nvGraphicFramePr>
          <p:cNvPr id="20" name="Diagramm 19">
            <a:extLst>
              <a:ext uri="{FF2B5EF4-FFF2-40B4-BE49-F238E27FC236}">
                <a16:creationId xmlns:a16="http://schemas.microsoft.com/office/drawing/2014/main" id="{ACEA8DCE-0E88-41FB-AE13-E5F04EE40A9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61074219"/>
              </p:ext>
            </p:extLst>
          </p:nvPr>
        </p:nvGraphicFramePr>
        <p:xfrm>
          <a:off x="-130223" y="5897419"/>
          <a:ext cx="3296010" cy="3462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1" name="Diagramm 20">
            <a:extLst>
              <a:ext uri="{FF2B5EF4-FFF2-40B4-BE49-F238E27FC236}">
                <a16:creationId xmlns:a16="http://schemas.microsoft.com/office/drawing/2014/main" id="{F843EF65-1717-4FB3-B62E-784BF1A6EDF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8231480"/>
              </p:ext>
            </p:extLst>
          </p:nvPr>
        </p:nvGraphicFramePr>
        <p:xfrm>
          <a:off x="3328292" y="5878369"/>
          <a:ext cx="3348088" cy="35004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  <p:extLst>
      <p:ext uri="{BB962C8B-B14F-4D97-AF65-F5344CB8AC3E}">
        <p14:creationId xmlns:p14="http://schemas.microsoft.com/office/powerpoint/2010/main" val="24478381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786679552C1A8E4993CBF6A23FAB2ED5" ma:contentTypeVersion="4" ma:contentTypeDescription="Ein neues Dokument erstellen." ma:contentTypeScope="" ma:versionID="1242b213505befe49d9e9c581dcaf711">
  <xsd:schema xmlns:xsd="http://www.w3.org/2001/XMLSchema" xmlns:xs="http://www.w3.org/2001/XMLSchema" xmlns:p="http://schemas.microsoft.com/office/2006/metadata/properties" xmlns:ns2="92c20cd1-3e4f-4a24-813b-8bbcc542bd4a" targetNamespace="http://schemas.microsoft.com/office/2006/metadata/properties" ma:root="true" ma:fieldsID="d2993d4b4c0543e65e074508ffe52722" ns2:_="">
    <xsd:import namespace="92c20cd1-3e4f-4a24-813b-8bbcc542bd4a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2c20cd1-3e4f-4a24-813b-8bbcc542bd4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haltstyp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BE81F08B-82DB-47A0-AFE5-DAE542561599}"/>
</file>

<file path=customXml/itemProps2.xml><?xml version="1.0" encoding="utf-8"?>
<ds:datastoreItem xmlns:ds="http://schemas.openxmlformats.org/officeDocument/2006/customXml" ds:itemID="{9852E854-36D4-4C04-B920-B9B2335C2167}"/>
</file>

<file path=customXml/itemProps3.xml><?xml version="1.0" encoding="utf-8"?>
<ds:datastoreItem xmlns:ds="http://schemas.openxmlformats.org/officeDocument/2006/customXml" ds:itemID="{A21453E1-2A27-4B7C-8406-8FF577447EF7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40</Words>
  <Application>Microsoft Office PowerPoint</Application>
  <PresentationFormat>A4-Papier (210 x 297 mm)</PresentationFormat>
  <Paragraphs>29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ünkel, Anna</dc:creator>
  <cp:lastModifiedBy>Roßbach, Lutz</cp:lastModifiedBy>
  <cp:revision>122</cp:revision>
  <dcterms:created xsi:type="dcterms:W3CDTF">2024-08-07T11:10:13Z</dcterms:created>
  <dcterms:modified xsi:type="dcterms:W3CDTF">2025-04-10T07:35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86679552C1A8E4993CBF6A23FAB2ED5</vt:lpwstr>
  </property>
</Properties>
</file>